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64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6" d="100"/>
          <a:sy n="76" d="100"/>
        </p:scale>
        <p:origin x="248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6231D-10BE-4D2C-BE99-6B8675673465}" type="datetimeFigureOut">
              <a:rPr lang="zh-CN" altLang="en-US" smtClean="0"/>
              <a:t>2023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44766-6644-47B1-83B7-BDC2E74A0D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3922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6231D-10BE-4D2C-BE99-6B8675673465}" type="datetimeFigureOut">
              <a:rPr lang="zh-CN" altLang="en-US" smtClean="0"/>
              <a:t>2023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44766-6644-47B1-83B7-BDC2E74A0D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87410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6231D-10BE-4D2C-BE99-6B8675673465}" type="datetimeFigureOut">
              <a:rPr lang="zh-CN" altLang="en-US" smtClean="0"/>
              <a:t>2023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44766-6644-47B1-83B7-BDC2E74A0D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98236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6231D-10BE-4D2C-BE99-6B8675673465}" type="datetimeFigureOut">
              <a:rPr lang="zh-CN" altLang="en-US" smtClean="0"/>
              <a:t>2023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44766-6644-47B1-83B7-BDC2E74A0D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2027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6231D-10BE-4D2C-BE99-6B8675673465}" type="datetimeFigureOut">
              <a:rPr lang="zh-CN" altLang="en-US" smtClean="0"/>
              <a:t>2023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44766-6644-47B1-83B7-BDC2E74A0D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99225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6231D-10BE-4D2C-BE99-6B8675673465}" type="datetimeFigureOut">
              <a:rPr lang="zh-CN" altLang="en-US" smtClean="0"/>
              <a:t>2023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44766-6644-47B1-83B7-BDC2E74A0D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16309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6231D-10BE-4D2C-BE99-6B8675673465}" type="datetimeFigureOut">
              <a:rPr lang="zh-CN" altLang="en-US" smtClean="0"/>
              <a:t>2023/4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44766-6644-47B1-83B7-BDC2E74A0D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6065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6231D-10BE-4D2C-BE99-6B8675673465}" type="datetimeFigureOut">
              <a:rPr lang="zh-CN" altLang="en-US" smtClean="0"/>
              <a:t>2023/4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44766-6644-47B1-83B7-BDC2E74A0D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16490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6231D-10BE-4D2C-BE99-6B8675673465}" type="datetimeFigureOut">
              <a:rPr lang="zh-CN" altLang="en-US" smtClean="0"/>
              <a:t>2023/4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44766-6644-47B1-83B7-BDC2E74A0D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43736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6231D-10BE-4D2C-BE99-6B8675673465}" type="datetimeFigureOut">
              <a:rPr lang="zh-CN" altLang="en-US" smtClean="0"/>
              <a:t>2023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44766-6644-47B1-83B7-BDC2E74A0D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04387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6231D-10BE-4D2C-BE99-6B8675673465}" type="datetimeFigureOut">
              <a:rPr lang="zh-CN" altLang="en-US" smtClean="0"/>
              <a:t>2023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44766-6644-47B1-83B7-BDC2E74A0D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76957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56231D-10BE-4D2C-BE99-6B8675673465}" type="datetimeFigureOut">
              <a:rPr lang="zh-CN" altLang="en-US" smtClean="0"/>
              <a:t>2023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244766-6644-47B1-83B7-BDC2E74A0D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7024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0865445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文本框 48">
            <a:extLst>
              <a:ext uri="{FF2B5EF4-FFF2-40B4-BE49-F238E27FC236}">
                <a16:creationId xmlns:a16="http://schemas.microsoft.com/office/drawing/2014/main" id="{4DB69349-53C0-4C97-952C-10E69D3AB6DC}"/>
              </a:ext>
            </a:extLst>
          </p:cNvPr>
          <p:cNvSpPr txBox="1"/>
          <p:nvPr/>
        </p:nvSpPr>
        <p:spPr>
          <a:xfrm>
            <a:off x="703988" y="6923709"/>
            <a:ext cx="596150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</a:t>
            </a:r>
            <a:r>
              <a:rPr lang="zh-CN" altLang="en-US" sz="12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1</a:t>
            </a:r>
            <a:r>
              <a:rPr lang="en-US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. FACS analysis of PI-strained E. coli treated with magnolol and honokiol in combination with kanamycin, tetracycline and gentamicin. The bacteria were stained with PI and analyzed by FACS. A: untreated; B: Magnolol (26.6 </a:t>
            </a:r>
            <a:r>
              <a:rPr lang="el-GR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g/ml); C: Honokiol (26.6 </a:t>
            </a:r>
            <a:r>
              <a:rPr lang="el-GR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g/ml); D: Kanamycin (14.56 </a:t>
            </a:r>
            <a:r>
              <a:rPr lang="el-GR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g/ml); E: Tetracycline (12.02 </a:t>
            </a:r>
            <a:r>
              <a:rPr lang="el-GR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g/ml); F: Gentamicin (9.42 </a:t>
            </a:r>
            <a:r>
              <a:rPr lang="el-GR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g/ml); G: Magnolol (26.63 </a:t>
            </a:r>
            <a:r>
              <a:rPr lang="el-GR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g/ml) plus kanamycin (14.56 </a:t>
            </a:r>
            <a:r>
              <a:rPr lang="el-GR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g/ml); H: Magnolol (26.63 </a:t>
            </a:r>
            <a:r>
              <a:rPr lang="el-GR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g/ml) plus tetracycline (12.02 </a:t>
            </a:r>
            <a:r>
              <a:rPr lang="el-GR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g/ml); I: Magnolol (26.63 </a:t>
            </a:r>
            <a:r>
              <a:rPr lang="el-GR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g/ml) plus gentamicin (9.42 </a:t>
            </a:r>
            <a:r>
              <a:rPr lang="el-GR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g/ml); J: Honokiol (26.6 </a:t>
            </a:r>
            <a:r>
              <a:rPr lang="el-GR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g/ml) plus kanamycin (14.56 </a:t>
            </a:r>
            <a:r>
              <a:rPr lang="el-GR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g/ml); K: Honokiol (26.6 </a:t>
            </a:r>
            <a:r>
              <a:rPr lang="el-GR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g/ml) plus tetracycline (12.02 </a:t>
            </a:r>
            <a:r>
              <a:rPr lang="el-GR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g/ml); L: Honokiol (26.6 </a:t>
            </a:r>
            <a:r>
              <a:rPr lang="el-GR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g/ml) plus gentamicin (9.42 </a:t>
            </a:r>
            <a:r>
              <a:rPr lang="el-GR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g/ml).  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D2575281-240D-42C2-A81C-B73089AF422E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1437" y="680307"/>
            <a:ext cx="1439545" cy="1439545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BE79C563-D393-423D-BD6B-51534CF62A34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19126" y="680307"/>
            <a:ext cx="1439545" cy="1439545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A74E3A2F-8F64-46A8-9CCA-468E35C9CD48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6815" y="680306"/>
            <a:ext cx="1439545" cy="1439545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822923FA-1DD3-456D-A2F5-FFF1CF9AEAC9}"/>
              </a:ext>
            </a:extLst>
          </p:cNvPr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2705" y="2077391"/>
            <a:ext cx="1439545" cy="1439545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0BA6C1A2-8BDC-4B35-BB09-4C9A06C01124}"/>
              </a:ext>
            </a:extLst>
          </p:cNvPr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19125" y="2090484"/>
            <a:ext cx="1439545" cy="1439545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5C5F122-D13E-4F24-B84A-ECEB0A03907F}"/>
              </a:ext>
            </a:extLst>
          </p:cNvPr>
          <p:cNvPicPr/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6813" y="2078261"/>
            <a:ext cx="1531620" cy="1462405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22724FA8-9756-4203-B493-AB1AB7B07AA7}"/>
              </a:ext>
            </a:extLst>
          </p:cNvPr>
          <p:cNvPicPr/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2705" y="3445844"/>
            <a:ext cx="1439545" cy="1439545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1304FE07-E009-4702-8A7D-5FCA940D9828}"/>
              </a:ext>
            </a:extLst>
          </p:cNvPr>
          <p:cNvPicPr/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08055" y="3445843"/>
            <a:ext cx="1439545" cy="1439545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CDD486EA-B2DF-4D4B-8351-DE5666C444BA}"/>
              </a:ext>
            </a:extLst>
          </p:cNvPr>
          <p:cNvPicPr/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6814" y="3445843"/>
            <a:ext cx="1439545" cy="1439545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3A0FCFDC-E385-443D-A410-E9B30844D4EF}"/>
              </a:ext>
            </a:extLst>
          </p:cNvPr>
          <p:cNvPicPr/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2704" y="4831204"/>
            <a:ext cx="1439545" cy="1439545"/>
          </a:xfrm>
          <a:prstGeom prst="rect">
            <a:avLst/>
          </a:prstGeom>
          <a:noFill/>
          <a:ln>
            <a:noFill/>
          </a:ln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63358F84-7902-4A0C-B676-65F5D33B0FE4}"/>
              </a:ext>
            </a:extLst>
          </p:cNvPr>
          <p:cNvPicPr/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19125" y="4842180"/>
            <a:ext cx="1439545" cy="1439545"/>
          </a:xfrm>
          <a:prstGeom prst="rect">
            <a:avLst/>
          </a:prstGeom>
          <a:noFill/>
          <a:ln>
            <a:noFill/>
          </a:ln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23EE4453-7A4C-4B54-A04C-4305416F04D6}"/>
              </a:ext>
            </a:extLst>
          </p:cNvPr>
          <p:cNvPicPr/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2290" y="4845098"/>
            <a:ext cx="1439545" cy="1439545"/>
          </a:xfrm>
          <a:prstGeom prst="rect">
            <a:avLst/>
          </a:prstGeom>
          <a:noFill/>
          <a:ln>
            <a:noFill/>
          </a:ln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F412E214-3685-4A3C-8EE0-93B19F004FCF}"/>
              </a:ext>
            </a:extLst>
          </p:cNvPr>
          <p:cNvSpPr txBox="1"/>
          <p:nvPr/>
        </p:nvSpPr>
        <p:spPr>
          <a:xfrm>
            <a:off x="1171690" y="574465"/>
            <a:ext cx="3869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1AF74DCC-A45E-4D50-863B-3A402796F34E}"/>
              </a:ext>
            </a:extLst>
          </p:cNvPr>
          <p:cNvSpPr txBox="1"/>
          <p:nvPr/>
        </p:nvSpPr>
        <p:spPr>
          <a:xfrm>
            <a:off x="1159833" y="1948102"/>
            <a:ext cx="3869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E32CE01-8E28-440D-BFDE-8DCE89698979}"/>
              </a:ext>
            </a:extLst>
          </p:cNvPr>
          <p:cNvSpPr txBox="1"/>
          <p:nvPr/>
        </p:nvSpPr>
        <p:spPr>
          <a:xfrm>
            <a:off x="1159833" y="3347344"/>
            <a:ext cx="3869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306E7EF0-9D7F-45A4-80E0-3BCFAA33F58C}"/>
              </a:ext>
            </a:extLst>
          </p:cNvPr>
          <p:cNvSpPr txBox="1"/>
          <p:nvPr/>
        </p:nvSpPr>
        <p:spPr>
          <a:xfrm>
            <a:off x="1159833" y="4695376"/>
            <a:ext cx="3869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706CC15-0645-47D2-85B0-F4F2DEB5A365}"/>
              </a:ext>
            </a:extLst>
          </p:cNvPr>
          <p:cNvSpPr txBox="1"/>
          <p:nvPr/>
        </p:nvSpPr>
        <p:spPr>
          <a:xfrm>
            <a:off x="2535257" y="548846"/>
            <a:ext cx="3869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4D3BD277-047E-42AD-8C72-594FE37995E0}"/>
              </a:ext>
            </a:extLst>
          </p:cNvPr>
          <p:cNvSpPr txBox="1"/>
          <p:nvPr/>
        </p:nvSpPr>
        <p:spPr>
          <a:xfrm>
            <a:off x="2543734" y="1955030"/>
            <a:ext cx="3869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10B1525-EF46-4253-9AF0-A34DE6CC9429}"/>
              </a:ext>
            </a:extLst>
          </p:cNvPr>
          <p:cNvSpPr txBox="1"/>
          <p:nvPr/>
        </p:nvSpPr>
        <p:spPr>
          <a:xfrm>
            <a:off x="2538093" y="3330448"/>
            <a:ext cx="3869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6010C5A1-068F-49FA-9053-54C1A8A77A49}"/>
              </a:ext>
            </a:extLst>
          </p:cNvPr>
          <p:cNvSpPr txBox="1"/>
          <p:nvPr/>
        </p:nvSpPr>
        <p:spPr>
          <a:xfrm>
            <a:off x="2541873" y="4707438"/>
            <a:ext cx="3869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3F9656FE-F374-4069-AA04-61B5320A1132}"/>
              </a:ext>
            </a:extLst>
          </p:cNvPr>
          <p:cNvSpPr txBox="1"/>
          <p:nvPr/>
        </p:nvSpPr>
        <p:spPr>
          <a:xfrm>
            <a:off x="3922681" y="548846"/>
            <a:ext cx="3869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127BD471-E61D-4C0D-B5C8-942C0AE7C1A8}"/>
              </a:ext>
            </a:extLst>
          </p:cNvPr>
          <p:cNvSpPr txBox="1"/>
          <p:nvPr/>
        </p:nvSpPr>
        <p:spPr>
          <a:xfrm>
            <a:off x="3922681" y="1948101"/>
            <a:ext cx="3869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6904A737-3FB2-4C2C-B075-153959FA9FAE}"/>
              </a:ext>
            </a:extLst>
          </p:cNvPr>
          <p:cNvSpPr txBox="1"/>
          <p:nvPr/>
        </p:nvSpPr>
        <p:spPr>
          <a:xfrm>
            <a:off x="3922681" y="3330449"/>
            <a:ext cx="3869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4008A568-3880-4CDF-B0A4-DCC185A0A25E}"/>
              </a:ext>
            </a:extLst>
          </p:cNvPr>
          <p:cNvSpPr txBox="1"/>
          <p:nvPr/>
        </p:nvSpPr>
        <p:spPr>
          <a:xfrm>
            <a:off x="3922681" y="4707438"/>
            <a:ext cx="3869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2" name="组合 31">
            <a:extLst>
              <a:ext uri="{FF2B5EF4-FFF2-40B4-BE49-F238E27FC236}">
                <a16:creationId xmlns:a16="http://schemas.microsoft.com/office/drawing/2014/main" id="{52A9492D-FA53-405D-84DA-36A1F41B1996}"/>
              </a:ext>
            </a:extLst>
          </p:cNvPr>
          <p:cNvGrpSpPr/>
          <p:nvPr/>
        </p:nvGrpSpPr>
        <p:grpSpPr>
          <a:xfrm>
            <a:off x="783334" y="5017642"/>
            <a:ext cx="994383" cy="1373505"/>
            <a:chOff x="1255431" y="4534150"/>
            <a:chExt cx="994383" cy="1373505"/>
          </a:xfrm>
        </p:grpSpPr>
        <p:sp>
          <p:nvSpPr>
            <p:cNvPr id="28" name="文本框 7">
              <a:extLst>
                <a:ext uri="{FF2B5EF4-FFF2-40B4-BE49-F238E27FC236}">
                  <a16:creationId xmlns:a16="http://schemas.microsoft.com/office/drawing/2014/main" id="{4B91FA13-7CD8-4EE6-A4DC-5E5F70A9B09B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717268" y="5072313"/>
              <a:ext cx="1373505" cy="297180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/>
              <a:r>
                <a:rPr lang="en-US" sz="1200" b="1" kern="1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SSC-A</a:t>
              </a:r>
              <a:endParaRPr lang="zh-CN" altLang="en-US" sz="105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30" name="直接箭头连接符 29">
              <a:extLst>
                <a:ext uri="{FF2B5EF4-FFF2-40B4-BE49-F238E27FC236}">
                  <a16:creationId xmlns:a16="http://schemas.microsoft.com/office/drawing/2014/main" id="{4609C2B1-8844-4B1C-A48D-7C50FF954353}"/>
                </a:ext>
              </a:extLst>
            </p:cNvPr>
            <p:cNvCxnSpPr/>
            <p:nvPr/>
          </p:nvCxnSpPr>
          <p:spPr>
            <a:xfrm flipV="1">
              <a:off x="1590418" y="5246263"/>
              <a:ext cx="7620" cy="594360"/>
            </a:xfrm>
            <a:prstGeom prst="straightConnector1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  <a:tailEnd type="stealth" w="lg" len="lg"/>
            </a:ln>
            <a:effectLst/>
          </p:spPr>
        </p:cxnSp>
        <p:cxnSp>
          <p:nvCxnSpPr>
            <p:cNvPr id="31" name="直接箭头连接符 30">
              <a:extLst>
                <a:ext uri="{FF2B5EF4-FFF2-40B4-BE49-F238E27FC236}">
                  <a16:creationId xmlns:a16="http://schemas.microsoft.com/office/drawing/2014/main" id="{2CC9CD81-9F05-439B-BA28-AAA08C7C591D}"/>
                </a:ext>
              </a:extLst>
            </p:cNvPr>
            <p:cNvCxnSpPr/>
            <p:nvPr/>
          </p:nvCxnSpPr>
          <p:spPr>
            <a:xfrm>
              <a:off x="1586874" y="5836363"/>
              <a:ext cx="662940" cy="0"/>
            </a:xfrm>
            <a:prstGeom prst="straightConnector1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  <a:tailEnd type="stealth" w="lg" len="lg"/>
            </a:ln>
            <a:effectLst/>
          </p:spPr>
        </p:cxnSp>
      </p:grpSp>
      <p:sp>
        <p:nvSpPr>
          <p:cNvPr id="34" name="文本框 6">
            <a:extLst>
              <a:ext uri="{FF2B5EF4-FFF2-40B4-BE49-F238E27FC236}">
                <a16:creationId xmlns:a16="http://schemas.microsoft.com/office/drawing/2014/main" id="{9E66300E-3D2E-42D3-AB64-F719D97D8316}"/>
              </a:ext>
            </a:extLst>
          </p:cNvPr>
          <p:cNvSpPr txBox="1">
            <a:spLocks/>
          </p:cNvSpPr>
          <p:nvPr/>
        </p:nvSpPr>
        <p:spPr>
          <a:xfrm>
            <a:off x="969506" y="6335033"/>
            <a:ext cx="1325880" cy="29718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sz="1200" b="1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luorescence</a:t>
            </a:r>
            <a:endParaRPr lang="zh-CN" altLang="en-US" sz="1050" kern="1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D91BF59B-4735-44C5-AD02-D428CD6BFF2D}"/>
              </a:ext>
            </a:extLst>
          </p:cNvPr>
          <p:cNvSpPr txBox="1"/>
          <p:nvPr/>
        </p:nvSpPr>
        <p:spPr>
          <a:xfrm>
            <a:off x="1512411" y="644728"/>
            <a:ext cx="7175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E23D387D-D4F2-408D-9F18-D316E5F338FA}"/>
              </a:ext>
            </a:extLst>
          </p:cNvPr>
          <p:cNvSpPr txBox="1"/>
          <p:nvPr/>
        </p:nvSpPr>
        <p:spPr>
          <a:xfrm>
            <a:off x="2988232" y="644727"/>
            <a:ext cx="7175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Mag</a:t>
            </a: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38D1143C-C118-4675-932C-D52F1AFD7E5A}"/>
              </a:ext>
            </a:extLst>
          </p:cNvPr>
          <p:cNvSpPr txBox="1"/>
          <p:nvPr/>
        </p:nvSpPr>
        <p:spPr>
          <a:xfrm>
            <a:off x="4345921" y="638253"/>
            <a:ext cx="7175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Hon</a:t>
            </a: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E7E8F1AC-362F-4397-8E08-F660212A3623}"/>
              </a:ext>
            </a:extLst>
          </p:cNvPr>
          <p:cNvSpPr txBox="1"/>
          <p:nvPr/>
        </p:nvSpPr>
        <p:spPr>
          <a:xfrm>
            <a:off x="4340818" y="2027081"/>
            <a:ext cx="8443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Gent</a:t>
            </a: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36C304AF-EFB8-4D28-88A0-02C423F38A2F}"/>
              </a:ext>
            </a:extLst>
          </p:cNvPr>
          <p:cNvSpPr txBox="1"/>
          <p:nvPr/>
        </p:nvSpPr>
        <p:spPr>
          <a:xfrm>
            <a:off x="2814938" y="4785307"/>
            <a:ext cx="1739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ag+Gent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9F4C0C78-7ACE-43E1-A573-01510ED8A5AB}"/>
              </a:ext>
            </a:extLst>
          </p:cNvPr>
          <p:cNvSpPr txBox="1"/>
          <p:nvPr/>
        </p:nvSpPr>
        <p:spPr>
          <a:xfrm>
            <a:off x="1608281" y="2029514"/>
            <a:ext cx="8443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Kana</a:t>
            </a: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2C713790-D78C-4049-82F5-59290BE228D8}"/>
              </a:ext>
            </a:extLst>
          </p:cNvPr>
          <p:cNvSpPr txBox="1"/>
          <p:nvPr/>
        </p:nvSpPr>
        <p:spPr>
          <a:xfrm>
            <a:off x="2957218" y="2027082"/>
            <a:ext cx="8443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Tetra</a:t>
            </a: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3400B1CE-901F-482A-BE32-5910E1F62702}"/>
              </a:ext>
            </a:extLst>
          </p:cNvPr>
          <p:cNvSpPr txBox="1"/>
          <p:nvPr/>
        </p:nvSpPr>
        <p:spPr>
          <a:xfrm>
            <a:off x="4254801" y="4785307"/>
            <a:ext cx="8443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Hon+Gent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27015A28-B4E2-4884-A70E-5981273800C0}"/>
              </a:ext>
            </a:extLst>
          </p:cNvPr>
          <p:cNvSpPr txBox="1"/>
          <p:nvPr/>
        </p:nvSpPr>
        <p:spPr>
          <a:xfrm>
            <a:off x="1476645" y="4785307"/>
            <a:ext cx="8443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Hon+Tetra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66EA1B4D-EDFA-41DC-A220-AA2DE5FBD9CC}"/>
              </a:ext>
            </a:extLst>
          </p:cNvPr>
          <p:cNvSpPr txBox="1"/>
          <p:nvPr/>
        </p:nvSpPr>
        <p:spPr>
          <a:xfrm>
            <a:off x="2881454" y="3378293"/>
            <a:ext cx="8443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Hon+Kana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A01810B4-340B-4951-B647-8AC5A713B0CD}"/>
              </a:ext>
            </a:extLst>
          </p:cNvPr>
          <p:cNvSpPr txBox="1"/>
          <p:nvPr/>
        </p:nvSpPr>
        <p:spPr>
          <a:xfrm>
            <a:off x="1479274" y="3378309"/>
            <a:ext cx="1739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ag+Kana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0143C00C-4F09-4301-B5E6-566A7D5FB6C6}"/>
              </a:ext>
            </a:extLst>
          </p:cNvPr>
          <p:cNvSpPr txBox="1"/>
          <p:nvPr/>
        </p:nvSpPr>
        <p:spPr>
          <a:xfrm>
            <a:off x="4229369" y="3379066"/>
            <a:ext cx="869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ag+Tetra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91593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41</Words>
  <Application>Microsoft Office PowerPoint</Application>
  <PresentationFormat>A4 纸张(210x297 毫米)</PresentationFormat>
  <Paragraphs>27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1" baseType="lpstr">
      <vt:lpstr>等线</vt:lpstr>
      <vt:lpstr>等线 Light</vt:lpstr>
      <vt:lpstr>宋体</vt:lpstr>
      <vt:lpstr>Arial</vt:lpstr>
      <vt:lpstr>Calibri</vt:lpstr>
      <vt:lpstr>Calibri Light</vt:lpstr>
      <vt:lpstr>Palatino Linotype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1</cp:revision>
  <dcterms:created xsi:type="dcterms:W3CDTF">2023-04-22T13:30:08Z</dcterms:created>
  <dcterms:modified xsi:type="dcterms:W3CDTF">2023-04-22T13:32:14Z</dcterms:modified>
</cp:coreProperties>
</file>